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79"/>
  </p:normalViewPr>
  <p:slideViewPr>
    <p:cSldViewPr snapToGrid="0" snapToObjects="1">
      <p:cViewPr varScale="1">
        <p:scale>
          <a:sx n="70" d="100"/>
          <a:sy n="70" d="100"/>
        </p:scale>
        <p:origin x="216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24BABC7-64FB-D142-8A25-182AA9088F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AA6B8F9B-3B96-D145-8D2B-2E18D7834E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  <a:endParaRPr lang="en-GB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E53A902D-9E1C-D748-BCE3-2BD6D95FA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1452CA77-2C0C-0140-A1BE-DE8C6C74C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104C95D8-9C5C-744C-81D4-F84A7C4F4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058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40F1CD-B294-6942-9227-976A9DDEE8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A351B86D-4C73-694C-9DB7-4A7D79516F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D9F87D82-31C8-5447-BC52-DB026EB67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1487FB8-AD3C-914C-BAE5-1DBC608FC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741B277C-1A1A-BE48-9663-A2846F316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7170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F404475C-70F7-C24C-B8ED-F0732FDAF1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5AC1E38D-FD25-C546-946D-B4C771A5CD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710317CF-C7E1-A344-B69C-5AC9D91EA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EEF6B92-654A-EE44-A9F2-DD9B6B03F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D142185E-DA1F-E642-9A6E-6C19619F9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439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181C18-3DBC-C744-9BD4-CA33CC4A1A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E0398EB5-F944-1D44-95E3-C366F19B8F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9E41584-F151-2747-BA4D-2D36AAEAE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7352BA01-FA2F-F040-81CD-154F9706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0644E6F-F803-4948-9589-1E0E8C866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443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C340A3-6C71-5B4E-9A06-8382812B3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C09035CA-9017-494B-8215-E71B00F990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5869DF3-AD23-7141-B3A7-9B66EE00F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FFD868E-487A-EB4A-A76B-D98C07E5D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76834652-BF20-FF46-96BD-CBB86C6D6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608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63ADF2-176F-9946-AD9D-AC4DD2A11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68EF7E34-927E-594A-ACD2-D0E6DF30DD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54B0E559-1F5A-0846-A648-3BFA390C21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D7070DBA-494D-0349-A87B-1A7FAB60C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9A9F99B1-B2ED-8E48-896C-269155C09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4BAE11E5-86DA-AB4F-9527-D0C339C4B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987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F7B9DD-25EB-7948-AD29-81C2E5139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6D2C61C5-6F8E-3146-8850-369FF63144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7D52C709-C4C1-D74B-9B89-DE0AE639EB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0300F829-A93D-3747-AD2A-BB1061F74A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564D7DC4-F72B-8D42-9962-FB9C51B931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242E3E48-FFC9-A340-AE5B-6ABC0B2EF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39001768-40DA-8641-9716-7F022AE0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D5AFA208-7A27-4F4C-AD3A-CC173C5E4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2584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8467518-161E-914D-ACA6-857C770A2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64FD647C-6B4E-EA4F-990B-55031D7DA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0B07EE2E-12D0-524D-986E-3C82ED046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D240F835-7202-9C4E-910B-FE6CF7E24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7989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B8612855-75DE-2C44-835B-8F1678FC98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F49A520F-7D15-234E-B1D5-E1A8EADEC9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BE3CCCD6-E1F6-0647-A325-FD55F3530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4430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9751F04-F9E4-6B47-AA12-61AC29FE2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6228B418-D53A-F44E-919F-0EC2B575B8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85AFC4FD-A60B-1A4F-A64F-6B6DDE438D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39EB57DF-6D38-604F-B075-FA921C3AC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42C986E1-B9DA-F448-A986-3998FF7F9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7EF58D4F-4728-6C40-8406-6286DF729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2151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A712E1E-9959-6C40-BB33-17925943F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C3129FCF-82B1-1B40-8662-297DA3DFC2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D22EDD4D-449F-3541-8A87-F2999FE63F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48177E32-3A18-CD49-94A2-293099A99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D33290CA-7FCD-4246-9C4D-438B94E9E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A9BEAD2D-0591-6A4C-BE54-FAB9FF21A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1155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3C77F66F-D193-BE40-AAFE-478D318642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GB"/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FAF6CBF7-B3DD-7F4C-B103-F0F8BACCD7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da-DK"/>
              <a:t>Rediger teksttypografien i masteren
Andet niveau
Tredje niveau
Fjerde niveau
Femte niveau</a:t>
            </a:r>
            <a:endParaRPr lang="en-GB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FAFC2F72-FE9C-2C45-9F12-2E0D421BBA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3F9EC-CBDE-8F4D-8A91-F4B0898C9C7D}" type="datetimeFigureOut">
              <a:rPr lang="en-GB" smtClean="0"/>
              <a:t>11/03/2021</a:t>
            </a:fld>
            <a:endParaRPr lang="en-GB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2F2FE6F-A0B6-2447-912A-87C6FBECB1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60CE72F8-B011-B043-B04E-3067EF08B4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47731-94BA-9B41-88F9-4811D57DCF8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632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>
            <a:extLst>
              <a:ext uri="{FF2B5EF4-FFF2-40B4-BE49-F238E27FC236}">
                <a16:creationId xmlns:a16="http://schemas.microsoft.com/office/drawing/2014/main" id="{B646119B-0B3F-7E41-94B8-22FF66BBE1C6}"/>
              </a:ext>
            </a:extLst>
          </p:cNvPr>
          <p:cNvSpPr txBox="1"/>
          <p:nvPr/>
        </p:nvSpPr>
        <p:spPr>
          <a:xfrm>
            <a:off x="0" y="4385527"/>
            <a:ext cx="759097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SM3: Interrupted regression model of the monthly admission rates for All Children, and for Previously healthy children &gt; 90 days. The model is interrupted at the time of intervention, with </a:t>
            </a:r>
            <a:r>
              <a:rPr lang="nb-NO" dirty="0"/>
              <a:t>a </a:t>
            </a:r>
            <a:r>
              <a:rPr lang="nb-NO" dirty="0" err="1"/>
              <a:t>reduction</a:t>
            </a:r>
            <a:r>
              <a:rPr lang="nb-NO" dirty="0"/>
              <a:t> in </a:t>
            </a:r>
            <a:r>
              <a:rPr lang="en-US" dirty="0"/>
              <a:t>admission rate after the intervention. </a:t>
            </a:r>
            <a:endParaRPr lang="en-GB" dirty="0"/>
          </a:p>
        </p:txBody>
      </p:sp>
      <p:sp>
        <p:nvSpPr>
          <p:cNvPr id="3" name="Tekstfelt 2">
            <a:extLst>
              <a:ext uri="{FF2B5EF4-FFF2-40B4-BE49-F238E27FC236}">
                <a16:creationId xmlns:a16="http://schemas.microsoft.com/office/drawing/2014/main" id="{A654B1A5-F985-3442-810E-5B877F0A58D2}"/>
              </a:ext>
            </a:extLst>
          </p:cNvPr>
          <p:cNvSpPr txBox="1"/>
          <p:nvPr/>
        </p:nvSpPr>
        <p:spPr>
          <a:xfrm>
            <a:off x="8069943" y="4385528"/>
            <a:ext cx="3909786" cy="2934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European Journal of Pediatrics:</a:t>
            </a:r>
            <a:endParaRPr lang="da-DK" sz="1000" dirty="0"/>
          </a:p>
          <a:p>
            <a:r>
              <a:rPr lang="en-US" sz="1000" b="1" dirty="0"/>
              <a:t>Viral lower respiratory tract infections - strict admission guidelines for young children can safely reduce admissions.</a:t>
            </a:r>
            <a:endParaRPr lang="da-DK" sz="1000" dirty="0"/>
          </a:p>
          <a:p>
            <a:r>
              <a:rPr lang="en-US" sz="1000" dirty="0"/>
              <a:t>Lise Beier Havdal</a:t>
            </a:r>
            <a:r>
              <a:rPr lang="en-US" sz="1000" baseline="30000" dirty="0"/>
              <a:t>1		</a:t>
            </a:r>
            <a:endParaRPr lang="da-DK" sz="1000" dirty="0"/>
          </a:p>
          <a:p>
            <a:r>
              <a:rPr lang="en-US" sz="1000" dirty="0"/>
              <a:t>Britt Nakstad</a:t>
            </a:r>
            <a:r>
              <a:rPr lang="en-US" sz="1000" baseline="30000" dirty="0"/>
              <a:t>2</a:t>
            </a:r>
            <a:r>
              <a:rPr lang="en-US" sz="1000" dirty="0"/>
              <a:t> 	</a:t>
            </a:r>
          </a:p>
          <a:p>
            <a:r>
              <a:rPr lang="en-US" sz="1000" dirty="0"/>
              <a:t>Hans Olav Fjærli</a:t>
            </a:r>
            <a:r>
              <a:rPr lang="en-US" sz="1000" baseline="30000" dirty="0"/>
              <a:t>1</a:t>
            </a:r>
            <a:r>
              <a:rPr lang="en-US" sz="1000" dirty="0"/>
              <a:t> </a:t>
            </a:r>
            <a:endParaRPr lang="da-DK" sz="1000" dirty="0"/>
          </a:p>
          <a:p>
            <a:r>
              <a:rPr lang="en-US" sz="1000" dirty="0"/>
              <a:t>Christian Ness</a:t>
            </a:r>
            <a:r>
              <a:rPr lang="en-US" sz="1000" baseline="30000" dirty="0"/>
              <a:t>1</a:t>
            </a:r>
            <a:endParaRPr lang="da-DK" sz="1000" dirty="0"/>
          </a:p>
          <a:p>
            <a:r>
              <a:rPr lang="en-US" sz="1000" dirty="0"/>
              <a:t>Christopher Inchley</a:t>
            </a:r>
            <a:r>
              <a:rPr lang="en-US" sz="1000" baseline="30000" dirty="0"/>
              <a:t>1	</a:t>
            </a:r>
          </a:p>
          <a:p>
            <a:endParaRPr lang="en-US" sz="1000" baseline="30000" dirty="0"/>
          </a:p>
          <a:p>
            <a:r>
              <a:rPr lang="en-US" sz="1000" baseline="30000" dirty="0"/>
              <a:t>1 </a:t>
            </a:r>
            <a:r>
              <a:rPr lang="en-US" sz="1000" dirty="0"/>
              <a:t>Department of Pediatric and Adolescent Medicine, </a:t>
            </a:r>
            <a:r>
              <a:rPr lang="en-US" sz="1000" dirty="0" err="1"/>
              <a:t>Akershus</a:t>
            </a:r>
            <a:r>
              <a:rPr lang="en-US" sz="1000" dirty="0"/>
              <a:t> University Hospital</a:t>
            </a:r>
            <a:endParaRPr lang="da-DK" sz="1000" dirty="0"/>
          </a:p>
          <a:p>
            <a:r>
              <a:rPr lang="en-US" sz="1000" baseline="30000" dirty="0"/>
              <a:t>2</a:t>
            </a:r>
            <a:r>
              <a:rPr lang="en-US" sz="1000" dirty="0"/>
              <a:t> </a:t>
            </a:r>
            <a:r>
              <a:rPr lang="en-US" sz="1000" dirty="0" err="1"/>
              <a:t>Divsion</a:t>
            </a:r>
            <a:r>
              <a:rPr lang="en-US" sz="1000" dirty="0"/>
              <a:t> of Pediatric and Adolescent Medicine, Institute of Clinical Medicine, University of Oslo, Norway. </a:t>
            </a:r>
            <a:endParaRPr lang="da-DK" sz="1000" dirty="0"/>
          </a:p>
          <a:p>
            <a:r>
              <a:rPr lang="en-US" sz="1000" dirty="0"/>
              <a:t> </a:t>
            </a:r>
          </a:p>
          <a:p>
            <a:r>
              <a:rPr lang="en-US" sz="1000" b="1" dirty="0"/>
              <a:t>Correspondence:</a:t>
            </a:r>
            <a:endParaRPr lang="da-DK" sz="1000" dirty="0"/>
          </a:p>
          <a:p>
            <a:r>
              <a:rPr lang="nb-NO" sz="1000" dirty="0"/>
              <a:t>Email: </a:t>
            </a:r>
            <a:r>
              <a:rPr lang="nb-NO" sz="1000" dirty="0" err="1"/>
              <a:t>lisebh@medisin.uio.no</a:t>
            </a:r>
            <a:endParaRPr lang="da-DK" sz="1000" dirty="0"/>
          </a:p>
          <a:p>
            <a:r>
              <a:rPr lang="en-US" sz="1000" dirty="0"/>
              <a:t> </a:t>
            </a:r>
            <a:endParaRPr lang="da-DK" sz="1000" dirty="0"/>
          </a:p>
          <a:p>
            <a:endParaRPr lang="en-GB" dirty="0"/>
          </a:p>
        </p:txBody>
      </p:sp>
      <p:pic>
        <p:nvPicPr>
          <p:cNvPr id="8" name="Billede 7">
            <a:extLst>
              <a:ext uri="{FF2B5EF4-FFF2-40B4-BE49-F238E27FC236}">
                <a16:creationId xmlns:a16="http://schemas.microsoft.com/office/drawing/2014/main" id="{69BA26D7-120C-F246-B9A5-04E692183C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818267" cy="4231467"/>
          </a:xfrm>
          <a:prstGeom prst="rect">
            <a:avLst/>
          </a:prstGeom>
        </p:spPr>
      </p:pic>
      <p:pic>
        <p:nvPicPr>
          <p:cNvPr id="4" name="Billede 3">
            <a:extLst>
              <a:ext uri="{FF2B5EF4-FFF2-40B4-BE49-F238E27FC236}">
                <a16:creationId xmlns:a16="http://schemas.microsoft.com/office/drawing/2014/main" id="{AC850FD1-1AF3-5048-AE21-3911C6485F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3733" y="-1"/>
            <a:ext cx="5818267" cy="4231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4480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3</TotalTime>
  <Words>124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Lise Beier Havdal</dc:creator>
  <cp:lastModifiedBy>Lise Beier Havdal</cp:lastModifiedBy>
  <cp:revision>11</cp:revision>
  <cp:lastPrinted>2020-11-23T10:23:51Z</cp:lastPrinted>
  <dcterms:created xsi:type="dcterms:W3CDTF">2020-10-21T11:14:01Z</dcterms:created>
  <dcterms:modified xsi:type="dcterms:W3CDTF">2021-03-11T19:15:46Z</dcterms:modified>
</cp:coreProperties>
</file>